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jpg" ContentType="image/jpeg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4" r:id="rId3"/>
    <p:sldId id="261" r:id="rId4"/>
    <p:sldId id="259" r:id="rId5"/>
    <p:sldId id="256" r:id="rId6"/>
    <p:sldId id="262" r:id="rId7"/>
    <p:sldId id="263" r:id="rId8"/>
  </p:sldIdLst>
  <p:sldSz cx="9144000" cy="6858000" type="screen4x3"/>
  <p:notesSz cx="6858000" cy="9144000"/>
  <p:defaultTextStyle>
    <a:defPPr>
      <a:defRPr lang="en-US"/>
    </a:defPPr>
    <a:lvl1pPr marL="0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5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69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04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38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73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08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42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077" algn="l" defTabSz="91426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ção Predefinida" id="{71EFE351-B310-41D0-9200-6B5B86A46C32}">
          <p14:sldIdLst>
            <p14:sldId id="260"/>
          </p14:sldIdLst>
        </p14:section>
        <p14:section name="Supplementary figures" id="{BFDC05B6-4A65-4C4E-8FED-AB9E4AAC9BAD}">
          <p14:sldIdLst>
            <p14:sldId id="264"/>
            <p14:sldId id="261"/>
            <p14:sldId id="259"/>
          </p14:sldIdLst>
        </p14:section>
        <p14:section name="Supplementary tables" id="{09C02B9A-54F0-478B-9E91-B1358C8FEFFA}">
          <p14:sldIdLst>
            <p14:sldId id="256"/>
            <p14:sldId id="262"/>
            <p14:sldId id="263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914" y="5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1800225" cy="180022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genomica\Desktop\Paper2\Resultados201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pt-PT" sz="2000" b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pt-PT" sz="2000" b="0" dirty="0" err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henolic</a:t>
            </a:r>
            <a:r>
              <a:rPr lang="pt-PT" sz="2000" b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2000" b="0" dirty="0" err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ex</a:t>
            </a:r>
            <a:r>
              <a:rPr lang="pt-PT" sz="2000" b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TPI)</a:t>
            </a:r>
          </a:p>
        </c:rich>
      </c:tx>
      <c:layout>
        <c:manualLayout>
          <c:xMode val="edge"/>
          <c:yMode val="edge"/>
          <c:x val="0.11933522349560881"/>
          <c:y val="4.215656881169550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679008540953846"/>
          <c:y val="0.15472605854693819"/>
          <c:w val="0.84606050978911596"/>
          <c:h val="0.65363854263107946"/>
        </c:manualLayout>
      </c:layout>
      <c:barChart>
        <c:barDir val="col"/>
        <c:grouping val="clustered"/>
        <c:varyColors val="0"/>
        <c:ser>
          <c:idx val="0"/>
          <c:order val="0"/>
          <c:tx>
            <c:v>Wine 1</c:v>
          </c:tx>
          <c:spPr>
            <a:gradFill rotWithShape="1">
              <a:gsLst>
                <a:gs pos="0">
                  <a:schemeClr val="accent1">
                    <a:shade val="51000"/>
                    <a:satMod val="130000"/>
                  </a:schemeClr>
                </a:gs>
                <a:gs pos="80000">
                  <a:schemeClr val="accent1">
                    <a:shade val="93000"/>
                    <a:satMod val="130000"/>
                  </a:schemeClr>
                </a:gs>
                <a:gs pos="100000">
                  <a:schemeClr val="accent1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'3 vinhos'!$V$8:$AH$8</c:f>
                <c:numCache>
                  <c:formatCode>General</c:formatCode>
                  <c:ptCount val="13"/>
                  <c:pt idx="0">
                    <c:v>2.1213203435594716E-2</c:v>
                  </c:pt>
                  <c:pt idx="1">
                    <c:v>0.15947831618540925</c:v>
                  </c:pt>
                  <c:pt idx="2">
                    <c:v>0.30347981810986957</c:v>
                  </c:pt>
                  <c:pt idx="3">
                    <c:v>1.5396861151979429</c:v>
                  </c:pt>
                  <c:pt idx="4">
                    <c:v>0.20816659994661224</c:v>
                  </c:pt>
                  <c:pt idx="5">
                    <c:v>0.23544284515213856</c:v>
                  </c:pt>
                  <c:pt idx="6">
                    <c:v>0.18681541692269291</c:v>
                  </c:pt>
                  <c:pt idx="7">
                    <c:v>0.30237945256470966</c:v>
                  </c:pt>
                  <c:pt idx="8">
                    <c:v>1.0346658075597803</c:v>
                  </c:pt>
                  <c:pt idx="9">
                    <c:v>9.9999999999997868E-3</c:v>
                  </c:pt>
                  <c:pt idx="10">
                    <c:v>0.17387735140993199</c:v>
                  </c:pt>
                  <c:pt idx="11">
                    <c:v>0.24269322199023188</c:v>
                  </c:pt>
                  <c:pt idx="12">
                    <c:v>0.17691806012954187</c:v>
                  </c:pt>
                </c:numCache>
              </c:numRef>
            </c:plus>
            <c:minus>
              <c:numRef>
                <c:f>'3 vinhos'!$V$8:$AH$8</c:f>
                <c:numCache>
                  <c:formatCode>General</c:formatCode>
                  <c:ptCount val="13"/>
                  <c:pt idx="0">
                    <c:v>2.1213203435594716E-2</c:v>
                  </c:pt>
                  <c:pt idx="1">
                    <c:v>0.15947831618540925</c:v>
                  </c:pt>
                  <c:pt idx="2">
                    <c:v>0.30347981810986957</c:v>
                  </c:pt>
                  <c:pt idx="3">
                    <c:v>1.5396861151979429</c:v>
                  </c:pt>
                  <c:pt idx="4">
                    <c:v>0.20816659994661224</c:v>
                  </c:pt>
                  <c:pt idx="5">
                    <c:v>0.23544284515213856</c:v>
                  </c:pt>
                  <c:pt idx="6">
                    <c:v>0.18681541692269291</c:v>
                  </c:pt>
                  <c:pt idx="7">
                    <c:v>0.30237945256470966</c:v>
                  </c:pt>
                  <c:pt idx="8">
                    <c:v>1.0346658075597803</c:v>
                  </c:pt>
                  <c:pt idx="9">
                    <c:v>9.9999999999997868E-3</c:v>
                  </c:pt>
                  <c:pt idx="10">
                    <c:v>0.17387735140993199</c:v>
                  </c:pt>
                  <c:pt idx="11">
                    <c:v>0.24269322199023188</c:v>
                  </c:pt>
                  <c:pt idx="12">
                    <c:v>0.17691806012954187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3 vinhos'!$V$2:$AH$2</c:f>
              <c:strCache>
                <c:ptCount val="13"/>
                <c:pt idx="0">
                  <c:v>NT</c:v>
                </c:pt>
                <c:pt idx="1">
                  <c:v>BCV1_10g/hL</c:v>
                </c:pt>
                <c:pt idx="2">
                  <c:v>BCV1_20g/hL</c:v>
                </c:pt>
                <c:pt idx="3">
                  <c:v>BCV5_10g/hL</c:v>
                </c:pt>
                <c:pt idx="4">
                  <c:v>BCV5_20g/hL</c:v>
                </c:pt>
                <c:pt idx="5">
                  <c:v>Bent_10g/hL</c:v>
                </c:pt>
                <c:pt idx="6">
                  <c:v>Bent_60g/hL</c:v>
                </c:pt>
                <c:pt idx="7">
                  <c:v>Cas_20g/hL</c:v>
                </c:pt>
                <c:pt idx="8">
                  <c:v>Cas_100g/hL</c:v>
                </c:pt>
                <c:pt idx="9">
                  <c:v>PVPP_10g/hL</c:v>
                </c:pt>
                <c:pt idx="10">
                  <c:v>PVPP_80g/hL</c:v>
                </c:pt>
                <c:pt idx="11">
                  <c:v>VP_20g/hL</c:v>
                </c:pt>
                <c:pt idx="12">
                  <c:v>VP_60g/hL</c:v>
                </c:pt>
              </c:strCache>
            </c:strRef>
          </c:cat>
          <c:val>
            <c:numRef>
              <c:f>'3 vinhos'!$V$3:$AH$3</c:f>
              <c:numCache>
                <c:formatCode>General</c:formatCode>
                <c:ptCount val="13"/>
                <c:pt idx="0">
                  <c:v>28.5</c:v>
                </c:pt>
                <c:pt idx="1">
                  <c:v>27.136666666666667</c:v>
                </c:pt>
                <c:pt idx="2">
                  <c:v>27.189999999999998</c:v>
                </c:pt>
                <c:pt idx="3">
                  <c:v>26.313333333333333</c:v>
                </c:pt>
                <c:pt idx="4">
                  <c:v>24.916666666666668</c:v>
                </c:pt>
                <c:pt idx="5">
                  <c:v>19.036666666666665</c:v>
                </c:pt>
                <c:pt idx="6">
                  <c:v>19.41</c:v>
                </c:pt>
                <c:pt idx="7">
                  <c:v>19.633333333333333</c:v>
                </c:pt>
                <c:pt idx="8">
                  <c:v>19.276666666666667</c:v>
                </c:pt>
                <c:pt idx="9">
                  <c:v>23.64</c:v>
                </c:pt>
                <c:pt idx="10">
                  <c:v>23.293333333333333</c:v>
                </c:pt>
                <c:pt idx="11">
                  <c:v>23.98</c:v>
                </c:pt>
                <c:pt idx="12">
                  <c:v>24.290000000000003</c:v>
                </c:pt>
              </c:numCache>
            </c:numRef>
          </c:val>
        </c:ser>
        <c:ser>
          <c:idx val="1"/>
          <c:order val="1"/>
          <c:tx>
            <c:v>Wine 2</c:v>
          </c:tx>
          <c:spPr>
            <a:gradFill rotWithShape="1">
              <a:gsLst>
                <a:gs pos="0">
                  <a:schemeClr val="accent2">
                    <a:shade val="51000"/>
                    <a:satMod val="130000"/>
                  </a:schemeClr>
                </a:gs>
                <a:gs pos="80000">
                  <a:schemeClr val="accent2">
                    <a:shade val="93000"/>
                    <a:satMod val="130000"/>
                  </a:schemeClr>
                </a:gs>
                <a:gs pos="100000">
                  <a:schemeClr val="accent2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'3 vinhos'!$V$9:$AH$9</c:f>
                <c:numCache>
                  <c:formatCode>General</c:formatCode>
                  <c:ptCount val="13"/>
                  <c:pt idx="0">
                    <c:v>7.7781745930519827E-2</c:v>
                  </c:pt>
                  <c:pt idx="1">
                    <c:v>0.24583192089989869</c:v>
                  </c:pt>
                  <c:pt idx="2">
                    <c:v>0.2253885533916922</c:v>
                  </c:pt>
                  <c:pt idx="3">
                    <c:v>0.30566866593311975</c:v>
                  </c:pt>
                  <c:pt idx="4">
                    <c:v>0.34078341117685579</c:v>
                  </c:pt>
                  <c:pt idx="5">
                    <c:v>1.9702114945693849</c:v>
                  </c:pt>
                  <c:pt idx="6">
                    <c:v>0.60781027741667415</c:v>
                  </c:pt>
                  <c:pt idx="7">
                    <c:v>0.15620499351813341</c:v>
                  </c:pt>
                  <c:pt idx="8">
                    <c:v>0.56871199506721593</c:v>
                  </c:pt>
                  <c:pt idx="9">
                    <c:v>7.571877794400407E-2</c:v>
                  </c:pt>
                  <c:pt idx="10">
                    <c:v>0.18009256878986765</c:v>
                  </c:pt>
                  <c:pt idx="11">
                    <c:v>0.11532562594670812</c:v>
                  </c:pt>
                  <c:pt idx="12">
                    <c:v>1.8614331396355155</c:v>
                  </c:pt>
                </c:numCache>
              </c:numRef>
            </c:plus>
            <c:minus>
              <c:numRef>
                <c:f>'3 vinhos'!$V$9:$AH$9</c:f>
                <c:numCache>
                  <c:formatCode>General</c:formatCode>
                  <c:ptCount val="13"/>
                  <c:pt idx="0">
                    <c:v>7.7781745930519827E-2</c:v>
                  </c:pt>
                  <c:pt idx="1">
                    <c:v>0.24583192089989869</c:v>
                  </c:pt>
                  <c:pt idx="2">
                    <c:v>0.2253885533916922</c:v>
                  </c:pt>
                  <c:pt idx="3">
                    <c:v>0.30566866593311975</c:v>
                  </c:pt>
                  <c:pt idx="4">
                    <c:v>0.34078341117685579</c:v>
                  </c:pt>
                  <c:pt idx="5">
                    <c:v>1.9702114945693849</c:v>
                  </c:pt>
                  <c:pt idx="6">
                    <c:v>0.60781027741667415</c:v>
                  </c:pt>
                  <c:pt idx="7">
                    <c:v>0.15620499351813341</c:v>
                  </c:pt>
                  <c:pt idx="8">
                    <c:v>0.56871199506721593</c:v>
                  </c:pt>
                  <c:pt idx="9">
                    <c:v>7.571877794400407E-2</c:v>
                  </c:pt>
                  <c:pt idx="10">
                    <c:v>0.18009256878986765</c:v>
                  </c:pt>
                  <c:pt idx="11">
                    <c:v>0.11532562594670812</c:v>
                  </c:pt>
                  <c:pt idx="12">
                    <c:v>1.8614331396355155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3 vinhos'!$V$2:$AH$2</c:f>
              <c:strCache>
                <c:ptCount val="13"/>
                <c:pt idx="0">
                  <c:v>NT</c:v>
                </c:pt>
                <c:pt idx="1">
                  <c:v>BCV1_10g/hL</c:v>
                </c:pt>
                <c:pt idx="2">
                  <c:v>BCV1_20g/hL</c:v>
                </c:pt>
                <c:pt idx="3">
                  <c:v>BCV5_10g/hL</c:v>
                </c:pt>
                <c:pt idx="4">
                  <c:v>BCV5_20g/hL</c:v>
                </c:pt>
                <c:pt idx="5">
                  <c:v>Bent_10g/hL</c:v>
                </c:pt>
                <c:pt idx="6">
                  <c:v>Bent_60g/hL</c:v>
                </c:pt>
                <c:pt idx="7">
                  <c:v>Cas_20g/hL</c:v>
                </c:pt>
                <c:pt idx="8">
                  <c:v>Cas_100g/hL</c:v>
                </c:pt>
                <c:pt idx="9">
                  <c:v>PVPP_10g/hL</c:v>
                </c:pt>
                <c:pt idx="10">
                  <c:v>PVPP_80g/hL</c:v>
                </c:pt>
                <c:pt idx="11">
                  <c:v>VP_20g/hL</c:v>
                </c:pt>
                <c:pt idx="12">
                  <c:v>VP_60g/hL</c:v>
                </c:pt>
              </c:strCache>
            </c:strRef>
          </c:cat>
          <c:val>
            <c:numRef>
              <c:f>'3 vinhos'!$V$4:$AH$4</c:f>
              <c:numCache>
                <c:formatCode>General</c:formatCode>
                <c:ptCount val="13"/>
                <c:pt idx="0">
                  <c:v>23.27</c:v>
                </c:pt>
                <c:pt idx="1">
                  <c:v>18.91333333333333</c:v>
                </c:pt>
                <c:pt idx="2">
                  <c:v>19.260000000000002</c:v>
                </c:pt>
                <c:pt idx="3">
                  <c:v>18.683333333333334</c:v>
                </c:pt>
                <c:pt idx="4">
                  <c:v>18.866666666666667</c:v>
                </c:pt>
                <c:pt idx="5">
                  <c:v>15.386666666666665</c:v>
                </c:pt>
                <c:pt idx="6">
                  <c:v>17.636666666666667</c:v>
                </c:pt>
                <c:pt idx="7">
                  <c:v>15.469999999999999</c:v>
                </c:pt>
                <c:pt idx="8">
                  <c:v>16.786666666666665</c:v>
                </c:pt>
                <c:pt idx="9">
                  <c:v>18.083333333333332</c:v>
                </c:pt>
                <c:pt idx="10">
                  <c:v>17.786666666666665</c:v>
                </c:pt>
                <c:pt idx="11">
                  <c:v>18.05</c:v>
                </c:pt>
                <c:pt idx="12">
                  <c:v>20.426666666666666</c:v>
                </c:pt>
              </c:numCache>
            </c:numRef>
          </c:val>
        </c:ser>
        <c:ser>
          <c:idx val="2"/>
          <c:order val="2"/>
          <c:tx>
            <c:v>Wine 3</c:v>
          </c:tx>
          <c:spPr>
            <a:gradFill rotWithShape="1">
              <a:gsLst>
                <a:gs pos="0">
                  <a:schemeClr val="accent3">
                    <a:shade val="51000"/>
                    <a:satMod val="130000"/>
                  </a:schemeClr>
                </a:gs>
                <a:gs pos="80000">
                  <a:schemeClr val="accent3">
                    <a:shade val="93000"/>
                    <a:satMod val="130000"/>
                  </a:schemeClr>
                </a:gs>
                <a:gs pos="100000">
                  <a:schemeClr val="accent3">
                    <a:shade val="94000"/>
                    <a:satMod val="135000"/>
                  </a:schemeClr>
                </a:gs>
              </a:gsLst>
              <a:lin ang="16200000" scaled="0"/>
            </a:gra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'3 vinhos'!$V$10:$AH$10</c:f>
                <c:numCache>
                  <c:formatCode>General</c:formatCode>
                  <c:ptCount val="13"/>
                  <c:pt idx="0">
                    <c:v>3.5355339059327882E-2</c:v>
                  </c:pt>
                  <c:pt idx="1">
                    <c:v>0.15502687938978121</c:v>
                  </c:pt>
                  <c:pt idx="2">
                    <c:v>0.19000000000000061</c:v>
                  </c:pt>
                  <c:pt idx="3">
                    <c:v>0.26576932353703586</c:v>
                  </c:pt>
                  <c:pt idx="4">
                    <c:v>8.7177978870813647E-2</c:v>
                  </c:pt>
                  <c:pt idx="5">
                    <c:v>0.37313983080519925</c:v>
                  </c:pt>
                  <c:pt idx="6">
                    <c:v>0.61329710037903518</c:v>
                  </c:pt>
                  <c:pt idx="7">
                    <c:v>0.22546248764114438</c:v>
                  </c:pt>
                  <c:pt idx="8">
                    <c:v>0.88357229472183041</c:v>
                  </c:pt>
                  <c:pt idx="9">
                    <c:v>0.23180451534284863</c:v>
                  </c:pt>
                  <c:pt idx="10">
                    <c:v>0.35501173689518201</c:v>
                  </c:pt>
                  <c:pt idx="11">
                    <c:v>0.47148700936505045</c:v>
                  </c:pt>
                  <c:pt idx="12">
                    <c:v>0.2900574655707604</c:v>
                  </c:pt>
                </c:numCache>
              </c:numRef>
            </c:plus>
            <c:minus>
              <c:numRef>
                <c:f>'3 vinhos'!$V$10:$AH$10</c:f>
                <c:numCache>
                  <c:formatCode>General</c:formatCode>
                  <c:ptCount val="13"/>
                  <c:pt idx="0">
                    <c:v>3.5355339059327882E-2</c:v>
                  </c:pt>
                  <c:pt idx="1">
                    <c:v>0.15502687938978121</c:v>
                  </c:pt>
                  <c:pt idx="2">
                    <c:v>0.19000000000000061</c:v>
                  </c:pt>
                  <c:pt idx="3">
                    <c:v>0.26576932353703586</c:v>
                  </c:pt>
                  <c:pt idx="4">
                    <c:v>8.7177978870813647E-2</c:v>
                  </c:pt>
                  <c:pt idx="5">
                    <c:v>0.37313983080519925</c:v>
                  </c:pt>
                  <c:pt idx="6">
                    <c:v>0.61329710037903518</c:v>
                  </c:pt>
                  <c:pt idx="7">
                    <c:v>0.22546248764114438</c:v>
                  </c:pt>
                  <c:pt idx="8">
                    <c:v>0.88357229472183041</c:v>
                  </c:pt>
                  <c:pt idx="9">
                    <c:v>0.23180451534284863</c:v>
                  </c:pt>
                  <c:pt idx="10">
                    <c:v>0.35501173689518201</c:v>
                  </c:pt>
                  <c:pt idx="11">
                    <c:v>0.47148700936505045</c:v>
                  </c:pt>
                  <c:pt idx="12">
                    <c:v>0.2900574655707604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3 vinhos'!$V$2:$AH$2</c:f>
              <c:strCache>
                <c:ptCount val="13"/>
                <c:pt idx="0">
                  <c:v>NT</c:v>
                </c:pt>
                <c:pt idx="1">
                  <c:v>BCV1_10g/hL</c:v>
                </c:pt>
                <c:pt idx="2">
                  <c:v>BCV1_20g/hL</c:v>
                </c:pt>
                <c:pt idx="3">
                  <c:v>BCV5_10g/hL</c:v>
                </c:pt>
                <c:pt idx="4">
                  <c:v>BCV5_20g/hL</c:v>
                </c:pt>
                <c:pt idx="5">
                  <c:v>Bent_10g/hL</c:v>
                </c:pt>
                <c:pt idx="6">
                  <c:v>Bent_60g/hL</c:v>
                </c:pt>
                <c:pt idx="7">
                  <c:v>Cas_20g/hL</c:v>
                </c:pt>
                <c:pt idx="8">
                  <c:v>Cas_100g/hL</c:v>
                </c:pt>
                <c:pt idx="9">
                  <c:v>PVPP_10g/hL</c:v>
                </c:pt>
                <c:pt idx="10">
                  <c:v>PVPP_80g/hL</c:v>
                </c:pt>
                <c:pt idx="11">
                  <c:v>VP_20g/hL</c:v>
                </c:pt>
                <c:pt idx="12">
                  <c:v>VP_60g/hL</c:v>
                </c:pt>
              </c:strCache>
            </c:strRef>
          </c:cat>
          <c:val>
            <c:numRef>
              <c:f>'3 vinhos'!$V$5:$AH$5</c:f>
              <c:numCache>
                <c:formatCode>General</c:formatCode>
                <c:ptCount val="13"/>
                <c:pt idx="0">
                  <c:v>26.26</c:v>
                </c:pt>
                <c:pt idx="1">
                  <c:v>24.693333333333332</c:v>
                </c:pt>
                <c:pt idx="2">
                  <c:v>24.709999999999997</c:v>
                </c:pt>
                <c:pt idx="3">
                  <c:v>24.166666666666668</c:v>
                </c:pt>
                <c:pt idx="4">
                  <c:v>24.110000000000003</c:v>
                </c:pt>
                <c:pt idx="5">
                  <c:v>21.893333333333334</c:v>
                </c:pt>
                <c:pt idx="6">
                  <c:v>21.653333333333336</c:v>
                </c:pt>
                <c:pt idx="7">
                  <c:v>22.663333333333338</c:v>
                </c:pt>
                <c:pt idx="8">
                  <c:v>21.459999999999997</c:v>
                </c:pt>
                <c:pt idx="9">
                  <c:v>26.473333333333329</c:v>
                </c:pt>
                <c:pt idx="10">
                  <c:v>26.636666666666667</c:v>
                </c:pt>
                <c:pt idx="11">
                  <c:v>26.05</c:v>
                </c:pt>
                <c:pt idx="12">
                  <c:v>25.1633333333333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6"/>
        <c:overlap val="6"/>
        <c:axId val="405363168"/>
        <c:axId val="405361208"/>
      </c:barChart>
      <c:catAx>
        <c:axId val="40536316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2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05361208"/>
        <c:crosses val="autoZero"/>
        <c:auto val="1"/>
        <c:lblAlgn val="ctr"/>
        <c:lblOffset val="100"/>
        <c:noMultiLvlLbl val="0"/>
      </c:catAx>
      <c:valAx>
        <c:axId val="405361208"/>
        <c:scaling>
          <c:orientation val="minMax"/>
          <c:max val="4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800" b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PI (</a:t>
                </a:r>
                <a:r>
                  <a:rPr lang="en-US" sz="1800" b="0" i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sz="1800" b="0" baseline="-250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sz="1800" b="0" i="1" baseline="-250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nm</a:t>
                </a:r>
                <a:r>
                  <a:rPr lang="en-US" sz="1800" b="0" i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800" b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10)</a:t>
                </a:r>
              </a:p>
            </c:rich>
          </c:tx>
          <c:layout>
            <c:manualLayout>
              <c:xMode val="edge"/>
              <c:yMode val="edge"/>
              <c:x val="2.8860515745322196E-2"/>
              <c:y val="0.309887139413256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05363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3266868839476176"/>
          <c:y val="1.3162618453111258E-2"/>
          <c:w val="0.33609521052906638"/>
          <c:h val="0.177394568210963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2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Faça clique para editar o estilo</a:t>
            </a:r>
            <a:endParaRPr lang="en-GB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4908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427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1" y="274639"/>
            <a:ext cx="2057400" cy="5851525"/>
          </a:xfrm>
        </p:spPr>
        <p:txBody>
          <a:bodyPr vert="eaVert"/>
          <a:lstStyle/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1181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1406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4324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3233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3265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11829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629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3575051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9700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304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que para editar o estilo</a:t>
            </a:r>
            <a:endParaRPr lang="en-GB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GB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2CA156-38E0-4BAF-861E-A48BED241080}" type="datetimeFigureOut">
              <a:rPr lang="en-GB" smtClean="0"/>
              <a:t>11/02/2015</a:t>
            </a:fld>
            <a:endParaRPr lang="en-GB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6553201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75C80-9547-457B-B6B5-E5D3EB704959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6999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/>
          <p:cNvSpPr txBox="1"/>
          <p:nvPr/>
        </p:nvSpPr>
        <p:spPr>
          <a:xfrm>
            <a:off x="2524125" y="2633692"/>
            <a:ext cx="4209824" cy="811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2251999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áfico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46307226"/>
              </p:ext>
            </p:extLst>
          </p:nvPr>
        </p:nvGraphicFramePr>
        <p:xfrm>
          <a:off x="0" y="352425"/>
          <a:ext cx="9072946" cy="5124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tângulo 2"/>
          <p:cNvSpPr/>
          <p:nvPr/>
        </p:nvSpPr>
        <p:spPr>
          <a:xfrm>
            <a:off x="0" y="5737755"/>
            <a:ext cx="91440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.  –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 Total phenolic content before and after the fining experiments in 250ml bottles, for the three types of wine tested. Untreated wine: NT. Wines treated with: Yeast protein extracts: BCV1 and BCV5; Bent: Bentonite;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s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: Casein; PVPP: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olyvinylpolypyrrolidon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; VP: Vegetable protein. </a:t>
            </a:r>
            <a:r>
              <a:rPr lang="en-US" sz="16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Bars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indicate mean ± SD (n = 3)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354672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tângulo 36"/>
          <p:cNvSpPr/>
          <p:nvPr/>
        </p:nvSpPr>
        <p:spPr>
          <a:xfrm>
            <a:off x="0" y="5780782"/>
            <a:ext cx="91440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Chromatic characterization using </a:t>
            </a:r>
            <a:r>
              <a:rPr lang="en-US" sz="16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ELab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ystem: Saturation (C*), Brilliance (L*), Green (-a*) and Yellow (b*) values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were obtained before and after treatment of wine 2 with YPE and different fining agents. Two dosages were tested by treatment (Min.-minimum; Max.-maximum).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8" name="Imagem 3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979" y="438150"/>
            <a:ext cx="8748041" cy="4962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32411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ângulo 2"/>
          <p:cNvSpPr/>
          <p:nvPr/>
        </p:nvSpPr>
        <p:spPr>
          <a:xfrm>
            <a:off x="0" y="5780782"/>
            <a:ext cx="91440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6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romatic characterization using </a:t>
            </a:r>
            <a:r>
              <a:rPr lang="en-US" sz="16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ELab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ystem: Saturation (C*), Brilliance (L*), Green (-a*) and Yellow (b*) values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were obtained before and after treatment of wine </a:t>
            </a:r>
            <a:r>
              <a:rPr lang="en-US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YPE and different fining agents. Two dosages were tested by treatment (Min.-minimum; Max.-maximum).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Imagem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433054"/>
            <a:ext cx="8714058" cy="49476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09408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5040218"/>
              </p:ext>
            </p:extLst>
          </p:nvPr>
        </p:nvGraphicFramePr>
        <p:xfrm>
          <a:off x="77099" y="1621878"/>
          <a:ext cx="8940313" cy="454898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560440"/>
                <a:gridCol w="600469"/>
                <a:gridCol w="880631"/>
                <a:gridCol w="762263"/>
                <a:gridCol w="813967"/>
                <a:gridCol w="854000"/>
                <a:gridCol w="652231"/>
                <a:gridCol w="773937"/>
                <a:gridCol w="733906"/>
                <a:gridCol w="800624"/>
                <a:gridCol w="760594"/>
                <a:gridCol w="747251"/>
              </a:tblGrid>
              <a:tr h="1135944"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2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ne </a:t>
                      </a:r>
                      <a:r>
                        <a:rPr lang="en-US" sz="18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sity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anol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ol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olatile acidity 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 H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table</a:t>
                      </a: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idity </a:t>
                      </a:r>
                      <a:endParaRPr lang="en-US" sz="1400" i="1" u="none" strike="noStrike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/L H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erol 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ic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ic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e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O</a:t>
                      </a: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V1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,5 ± 0,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56 ± 0,17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4 ± 0,0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47 ± 0,0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29 ± 0,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1 ± 0,0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3 ± 0,0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9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,1 ± 0,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,9 ± 0,4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,6 ± 0,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50 ± 0,1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3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41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0 ± 0,0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79 ± 0,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1 ± 0,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7 ± 0,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,3 ± 0,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2 ± 0,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V5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,5 ± 0,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54 ± 0,1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3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47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0 ± 0,04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75 ± 0,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5 ± 0,0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8 ± 0,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5 ± 0,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0 ± 0,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hL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,6 ± 0,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51 ± 0,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3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46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29 ± 0,0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0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2 ± 0,0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7 ± 0,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,0 ± 0,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4 ± 0,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t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,7 ± 0,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44 ± 0,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8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03 ± 0,1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27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75 ± 0,0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6 </a:t>
                      </a:r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0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5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,7 ± 0,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8 ± 0,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g/hL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,2 ± 0,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19 ± 0,1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8 ± 0,0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08 ± 0,0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29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2 ± 0,0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0 </a:t>
                      </a:r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7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6 ± 0,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1 ± 0,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,8 ± 0,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34 ± 0,1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70 ± 0,0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3 ± 0,0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28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93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2 ± 0,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2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,1 ± 0,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,9 ± 0,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,1 ± 0,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11 ± 0,1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9 ± 0,0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3 ± 0,0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1 ± 0,0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02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7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8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4 ± 0,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2 ± 0,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PP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,9 ± 0,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47 ± 0,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8 ± 0,0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43 ± 0,1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28 ± 0,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7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89 ± 0,0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2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,1 ± 0,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,8 ± 0,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,0 ± 0,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31 ± 0,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8 ± 0,0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28 ± 0,0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28 ± 0,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2 ± 0,0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0 ± 0,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8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,4 ± 0,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3 ± 0,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P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7,9 ± 0,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47 ± 0,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8 ± 0,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39 ± 0,1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28 ± 0,0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01 ± 0,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1 ± 0,0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0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,0 ± 0,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2 ± 0,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,0 ± 0,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38 ± 0,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8 ± 0,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32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0 ± 0,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5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1 </a:t>
                      </a:r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8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3 ± 0,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2 ± 0,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12085">
                <a:tc gridSpan="2"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6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T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,3 ± 0,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04 ± 0,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70 ± 0,1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9 ± 0,0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1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21 ± 0,0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22 ± 0,0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5 ± 0,0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,2 ± 0,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,3 ± 0,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3" name="Retângulo 2"/>
          <p:cNvSpPr/>
          <p:nvPr/>
        </p:nvSpPr>
        <p:spPr>
          <a:xfrm>
            <a:off x="19050" y="352425"/>
            <a:ext cx="90678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86"/>
              </a:spcAft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ventional oenological parameters acquired by Infrared Fourier-transform spectrometer – Wine 1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Wines treated with: Yeast protein extracts: BCV1 and BCV5; Bent: Bentonite;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s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: Casein; PVPP: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olyvinylpolypyrrolidon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; VP: Vegetable protein. Untreated wine: NT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ar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to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ining experiments after fermentation, performed in triplicates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Values are presented as mean ± SD (n = 3).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11813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3219982"/>
              </p:ext>
            </p:extLst>
          </p:nvPr>
        </p:nvGraphicFramePr>
        <p:xfrm>
          <a:off x="77099" y="1621878"/>
          <a:ext cx="8940313" cy="454898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560440"/>
                <a:gridCol w="600469"/>
                <a:gridCol w="880631"/>
                <a:gridCol w="762263"/>
                <a:gridCol w="813967"/>
                <a:gridCol w="854000"/>
                <a:gridCol w="652231"/>
                <a:gridCol w="773937"/>
                <a:gridCol w="733906"/>
                <a:gridCol w="800624"/>
                <a:gridCol w="760594"/>
                <a:gridCol w="747251"/>
              </a:tblGrid>
              <a:tr h="1135944"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2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ne </a:t>
                      </a:r>
                      <a:r>
                        <a:rPr lang="en-US" sz="18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sity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anol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ol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olatile acidity 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 H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table</a:t>
                      </a: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idity </a:t>
                      </a:r>
                      <a:endParaRPr lang="en-US" sz="1400" i="1" u="none" strike="noStrike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/L H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erol 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ic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ic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e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O</a:t>
                      </a: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V1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8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32 ± 0,1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0 ± 0,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53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40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81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5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2 ± 0,02</a:t>
                      </a:r>
                    </a:p>
                  </a:txBody>
                  <a:tcPr marL="9525" marR="9525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,1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,9 ± 0,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8 ± 0,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27 ± 0,1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0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51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40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03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9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48 ± 0,04</a:t>
                      </a:r>
                    </a:p>
                  </a:txBody>
                  <a:tcPr marL="9525" marR="9525" marT="0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,3 ± 0,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,2 ± 0,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V5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7 ± 0,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30 ± 0,1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8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58 ± 0,0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9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22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9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1 ± 0,01</a:t>
                      </a:r>
                    </a:p>
                  </a:txBody>
                  <a:tcPr marL="9525" marR="9525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,5 ± 0,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,0 ± 0,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hL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6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27 ± 0,1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4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4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8 ± 0,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32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27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0 ± 0,02</a:t>
                      </a:r>
                    </a:p>
                  </a:txBody>
                  <a:tcPr marL="9525" marR="9525" marT="0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,0 ± 0,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,0 ± 0,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t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1 ± 0,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20 ± 0,1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0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4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5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21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8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35 ± 0,03</a:t>
                      </a:r>
                    </a:p>
                  </a:txBody>
                  <a:tcPr marL="9525" marR="9525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,7 ± 0,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,0 ± 0,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g/hL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3 ± 0,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02 ± 0,1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0 ± 0,0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44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7 ± 0,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05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04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41 ± 0,02</a:t>
                      </a:r>
                    </a:p>
                  </a:txBody>
                  <a:tcPr marL="9525" marR="9525" marT="0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,6 ± 0,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,0 ± 0,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3 ± 0,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18 ± 0,1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62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5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6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01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3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29 ± 0,04</a:t>
                      </a:r>
                    </a:p>
                  </a:txBody>
                  <a:tcPr marL="9525" marR="9525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,1 ± 0,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,0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4 ± 0,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,97 ± 0,1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7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44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8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54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10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27 ± 0,04</a:t>
                      </a:r>
                    </a:p>
                  </a:txBody>
                  <a:tcPr marL="9525" marR="9525" marT="0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,4 ± 0,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,2 ± 0,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PP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9 ± 0,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29 ± 0,1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9 ± 0,0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4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6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0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87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3 ± 0,00</a:t>
                      </a:r>
                    </a:p>
                  </a:txBody>
                  <a:tcPr marL="9525" marR="9525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,1 ± 0,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,0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0,0 ± 0,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10 ± 0,1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8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51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6 ± 0,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52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0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1 ± 0,00</a:t>
                      </a:r>
                    </a:p>
                  </a:txBody>
                  <a:tcPr marL="9525" marR="9525" marT="0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,4 ± 0,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,0 ± 0,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P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9 ± 0,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26 ± 0,1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9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0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6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9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0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2 ± 0,01</a:t>
                      </a:r>
                    </a:p>
                  </a:txBody>
                  <a:tcPr marL="9525" marR="9525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0 ± 0,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,0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0,0 ± 0,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20 ± 0,1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9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50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7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65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92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0 ± 0,01</a:t>
                      </a:r>
                    </a:p>
                  </a:txBody>
                  <a:tcPr marL="9525" marR="9525" marT="0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,3 ± 0,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,0 ± 0,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12085">
                <a:tc gridSpan="2"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6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T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9,3 ± 0,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,96 ± 0,1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53 ± 0,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49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36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02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20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27 ± 0,00</a:t>
                      </a:r>
                    </a:p>
                  </a:txBody>
                  <a:tcPr marL="9525" marR="9525" marT="0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,2 ± 0,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,3 ± 0,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3" name="Retângulo 2"/>
          <p:cNvSpPr/>
          <p:nvPr/>
        </p:nvSpPr>
        <p:spPr>
          <a:xfrm>
            <a:off x="19050" y="352425"/>
            <a:ext cx="90678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86"/>
              </a:spcAft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ventional oenological parameters acquired by Infrared Fourier-transform spectrometer – Wine </a:t>
            </a:r>
            <a:r>
              <a:rPr lang="en-US" sz="16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Wines treated with: Yeast protein extracts: BCV1 and BCV5; Bent: Bentonite;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s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: Casein; PVPP: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olyvinylpolypyrrolidon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; VP: Vegetable protein. Untreated wine: NT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ar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to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ining experiments after fermentation, performed in triplicates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Values are presented as mean ± SD (n = 3).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9219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6235924"/>
              </p:ext>
            </p:extLst>
          </p:nvPr>
        </p:nvGraphicFramePr>
        <p:xfrm>
          <a:off x="77099" y="1621878"/>
          <a:ext cx="8940313" cy="454898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560440"/>
                <a:gridCol w="600469"/>
                <a:gridCol w="880631"/>
                <a:gridCol w="762263"/>
                <a:gridCol w="813967"/>
                <a:gridCol w="854000"/>
                <a:gridCol w="652231"/>
                <a:gridCol w="773937"/>
                <a:gridCol w="733906"/>
                <a:gridCol w="800624"/>
                <a:gridCol w="760594"/>
                <a:gridCol w="747251"/>
              </a:tblGrid>
              <a:tr h="1135944"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2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ne </a:t>
                      </a:r>
                      <a:r>
                        <a:rPr lang="en-US" sz="18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8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nsity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anol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ol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olatile acidity 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 H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table</a:t>
                      </a: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idity </a:t>
                      </a:r>
                      <a:endParaRPr lang="en-US" sz="1400" i="1" u="none" strike="noStrike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/L H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200" i="1" u="none" strike="noStrike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erol 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ic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ic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2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e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O</a:t>
                      </a: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algn="ctr" rtl="0" fontAlgn="ctr">
                        <a:lnSpc>
                          <a:spcPct val="150000"/>
                        </a:lnSpc>
                      </a:pPr>
                      <a:r>
                        <a:rPr lang="en-US" sz="1400" i="1" u="none" strike="noStrike" baseline="-25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g/L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V1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4 ± 0,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60 ± 0,1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86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69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3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21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31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5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5,1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2,0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5 ± 0,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53 ± 0,1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85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63 ± 0,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4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23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34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3 ± 0,0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4,3 ± 0,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3,0 ± 0,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V5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5 ± 0,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58 ± 0,1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86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66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3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22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28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6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4,5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4,0 ± 0,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hL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7 ± 0,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50 ± 0,1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86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57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3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16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23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4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6,0 ± 0,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5,4 ± 0,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nt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7 ± 0,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48 ± 0,2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5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,97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2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11 ± 0,0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12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52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8,7 ± 0,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2,0 ± 0,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g/hL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7 ± 0,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23 ± 0,1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3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,68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4 ± 0,0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10 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± 0,0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07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47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0,6 ± 0,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2,0 ± 0,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8 ± 0,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42 ± 0,1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5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,94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3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05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16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52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2,1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0,0 ± 0,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8 ± 0,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15 ± 0,1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1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,69 ± 0,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5 ± 0,0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01 ± 0,0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9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50 ± 0,0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3,4 ± 0,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1,0 ± 0,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PP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90,1 ± 0,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43 ± 0,1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1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58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3 ± 0,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13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03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8 ± 0,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5,1 ± 0,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2,0 ± 0,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90,1 ± 0,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33 ± 0,1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1 ± 0,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50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5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14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9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4 ± 0,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3,4 ± 0,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3,0 ± 0,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1746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6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P</a:t>
                      </a:r>
                      <a:endParaRPr lang="en-US" sz="16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90,2 ± 0,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39 ± 0,1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1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64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3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05 ± 0,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07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7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2,5 ± 0,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4,0 ± 0,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41746">
                <a:tc vMerge="1">
                  <a:txBody>
                    <a:bodyPr/>
                    <a:lstStyle/>
                    <a:p>
                      <a:pPr algn="ctr" rtl="0" fontAlgn="ctr"/>
                      <a:endParaRPr lang="en-US" sz="14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g/</a:t>
                      </a:r>
                      <a:r>
                        <a:rPr lang="en-US" sz="12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90,3 ± 0,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14 ± 0,1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90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51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3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11 ± 0,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05 ± 0,0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3 ± 0,0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0,2 ± 0,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5,0 ± 0,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12085">
                <a:tc gridSpan="2"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600" i="1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T</a:t>
                      </a: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89,8 ± 0,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49 ± 0,2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89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64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,32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56 ± 0,0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04 ± 0,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,78 ± 0,0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7,2 ± 0,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1,0 ± 0,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</a:tbl>
          </a:graphicData>
        </a:graphic>
      </p:graphicFrame>
      <p:sp>
        <p:nvSpPr>
          <p:cNvPr id="3" name="Retângulo 2"/>
          <p:cNvSpPr/>
          <p:nvPr/>
        </p:nvSpPr>
        <p:spPr>
          <a:xfrm>
            <a:off x="19050" y="352425"/>
            <a:ext cx="90678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86"/>
              </a:spcAft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ventional oenological parameters acquired by Infrared Fourier-transform spectrometer – Wine </a:t>
            </a:r>
            <a:r>
              <a:rPr lang="en-US" sz="16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Wines treated with: Yeast protein extracts: BCV1 and BCV5; Bent: Bentonite;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s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: Casein; PVPP: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olyvinylpolypyrrolidon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; VP: Vegetable protein. Untreated wine: NT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are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to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ining experiments after fermentation, performed in triplicates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Values are presented as mean ± SD (n = 3).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42837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9ECAD1AC5EDE640BBACFD13549997CA" ma:contentTypeVersion="7" ma:contentTypeDescription="Create a new document." ma:contentTypeScope="" ma:versionID="b9d94c1ec22064a3213cdca5886d935e">
  <xsd:schema xmlns:xsd="http://www.w3.org/2001/XMLSchema" xmlns:p="http://schemas.microsoft.com/office/2006/metadata/properties" xmlns:ns2="1ddddb63-acec-4d6c-ba0a-6e5edd38f2a1" targetNamespace="http://schemas.microsoft.com/office/2006/metadata/properties" ma:root="true" ma:fieldsID="8d74c06e093082de718bb34e38604144" ns2:_="">
    <xsd:import namespace="1ddddb63-acec-4d6c-ba0a-6e5edd38f2a1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ddddb63-acec-4d6c-ba0a-6e5edd38f2a1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1ddddb63-acec-4d6c-ba0a-6e5edd38f2a1">Presentation</DocumentType>
    <FileFormat xmlns="1ddddb63-acec-4d6c-ba0a-6e5edd38f2a1">PPTX</FileFormat>
    <StageName xmlns="1ddddb63-acec-4d6c-ba0a-6e5edd38f2a1" xsi:nil="true"/>
    <Checked_x0020_Out_x0020_To xmlns="1ddddb63-acec-4d6c-ba0a-6e5edd38f2a1">
      <UserInfo>
        <DisplayName/>
        <AccountId xsi:nil="true"/>
        <AccountType/>
      </UserInfo>
    </Checked_x0020_Out_x0020_To>
    <TitleName xmlns="1ddddb63-acec-4d6c-ba0a-6e5edd38f2a1">Presentation 1.PPTX</TitleName>
    <DocumentId xmlns="1ddddb63-acec-4d6c-ba0a-6e5edd38f2a1">Presentation 1.PPTX</DocumentId>
    <IsDeleted xmlns="1ddddb63-acec-4d6c-ba0a-6e5edd38f2a1">false</IsDeleted>
  </documentManagement>
</p:properties>
</file>

<file path=customXml/itemProps1.xml><?xml version="1.0" encoding="utf-8"?>
<ds:datastoreItem xmlns:ds="http://schemas.openxmlformats.org/officeDocument/2006/customXml" ds:itemID="{F88BF9B7-EA35-4346-99F0-65E678BAFE00}"/>
</file>

<file path=customXml/itemProps2.xml><?xml version="1.0" encoding="utf-8"?>
<ds:datastoreItem xmlns:ds="http://schemas.openxmlformats.org/officeDocument/2006/customXml" ds:itemID="{C16ACE81-C022-4ABC-A0AD-881B60FC3CF7}"/>
</file>

<file path=customXml/itemProps3.xml><?xml version="1.0" encoding="utf-8"?>
<ds:datastoreItem xmlns:ds="http://schemas.openxmlformats.org/officeDocument/2006/customXml" ds:itemID="{5819CD4A-9848-4552-836C-087B76383518}"/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801</Words>
  <Application>Microsoft Office PowerPoint</Application>
  <PresentationFormat>Apresentação no Ecrã (4:3)</PresentationFormat>
  <Paragraphs>525</Paragraphs>
  <Slides>7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Ana Gomes</dc:creator>
  <cp:lastModifiedBy>genomica</cp:lastModifiedBy>
  <cp:revision>4</cp:revision>
  <dcterms:created xsi:type="dcterms:W3CDTF">2015-02-10T19:10:47Z</dcterms:created>
  <dcterms:modified xsi:type="dcterms:W3CDTF">2015-02-11T10:49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9ECAD1AC5EDE640BBACFD13549997CA</vt:lpwstr>
  </property>
</Properties>
</file>